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797675" cy="9928225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orient="horz" pos="262">
          <p15:clr>
            <a:srgbClr val="A4A3A4"/>
          </p15:clr>
        </p15:guide>
        <p15:guide id="3" orient="horz" pos="4980">
          <p15:clr>
            <a:srgbClr val="A4A3A4"/>
          </p15:clr>
        </p15:guide>
        <p15:guide id="4" pos="255">
          <p15:clr>
            <a:srgbClr val="A4A3A4"/>
          </p15:clr>
        </p15:guide>
        <p15:guide id="5" pos="4065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2" d="100"/>
          <a:sy n="62" d="100"/>
        </p:scale>
        <p:origin x="2598" y="96"/>
      </p:cViewPr>
      <p:guideLst>
        <p:guide orient="horz" pos="3120"/>
        <p:guide orient="horz" pos="262"/>
        <p:guide orient="horz" pos="4980"/>
        <p:guide pos="255"/>
        <p:guide pos="406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152D6B-D5A0-4061-88FA-3BDA86F05B18}" type="datetimeFigureOut">
              <a:rPr lang="es-ES" smtClean="0"/>
              <a:t>04/06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69DFD-D879-4F9A-BC31-DDE1686713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464180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152D6B-D5A0-4061-88FA-3BDA86F05B18}" type="datetimeFigureOut">
              <a:rPr lang="es-ES" smtClean="0"/>
              <a:t>04/06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69DFD-D879-4F9A-BC31-DDE1686713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062484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6" y="529697"/>
            <a:ext cx="3357563" cy="1126807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152D6B-D5A0-4061-88FA-3BDA86F05B18}" type="datetimeFigureOut">
              <a:rPr lang="es-ES" smtClean="0"/>
              <a:t>04/06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69DFD-D879-4F9A-BC31-DDE1686713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947082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152D6B-D5A0-4061-88FA-3BDA86F05B18}" type="datetimeFigureOut">
              <a:rPr lang="es-ES" smtClean="0"/>
              <a:t>04/06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69DFD-D879-4F9A-BC31-DDE1686713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671531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152D6B-D5A0-4061-88FA-3BDA86F05B18}" type="datetimeFigureOut">
              <a:rPr lang="es-ES" smtClean="0"/>
              <a:t>04/06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69DFD-D879-4F9A-BC31-DDE1686713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262574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152D6B-D5A0-4061-88FA-3BDA86F05B18}" type="datetimeFigureOut">
              <a:rPr lang="es-ES" smtClean="0"/>
              <a:t>04/06/2013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69DFD-D879-4F9A-BC31-DDE1686713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998072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152D6B-D5A0-4061-88FA-3BDA86F05B18}" type="datetimeFigureOut">
              <a:rPr lang="es-ES" smtClean="0"/>
              <a:t>04/06/2013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69DFD-D879-4F9A-BC31-DDE1686713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412158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152D6B-D5A0-4061-88FA-3BDA86F05B18}" type="datetimeFigureOut">
              <a:rPr lang="es-ES" smtClean="0"/>
              <a:t>04/06/2013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69DFD-D879-4F9A-BC31-DDE1686713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728977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152D6B-D5A0-4061-88FA-3BDA86F05B18}" type="datetimeFigureOut">
              <a:rPr lang="es-ES" smtClean="0"/>
              <a:t>04/06/2013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69DFD-D879-4F9A-BC31-DDE1686713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294497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152D6B-D5A0-4061-88FA-3BDA86F05B18}" type="datetimeFigureOut">
              <a:rPr lang="es-ES" smtClean="0"/>
              <a:t>04/06/2013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69DFD-D879-4F9A-BC31-DDE1686713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279154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152D6B-D5A0-4061-88FA-3BDA86F05B18}" type="datetimeFigureOut">
              <a:rPr lang="es-ES" smtClean="0"/>
              <a:t>04/06/2013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69DFD-D879-4F9A-BC31-DDE1686713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218555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152D6B-D5A0-4061-88FA-3BDA86F05B18}" type="datetimeFigureOut">
              <a:rPr lang="es-ES" smtClean="0"/>
              <a:t>04/06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069DFD-D879-4F9A-BC31-DDE1686713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34847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92 Rectángulo"/>
          <p:cNvSpPr/>
          <p:nvPr/>
        </p:nvSpPr>
        <p:spPr>
          <a:xfrm>
            <a:off x="310684" y="491117"/>
            <a:ext cx="6430683" cy="7270195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>
              <a:lnSpc>
                <a:spcPct val="85000"/>
              </a:lnSpc>
            </a:pPr>
            <a:r>
              <a:rPr lang="es-ES_tradnl" sz="980" b="1" i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t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  1 -------------MSFFPPQ----QQQTPQP-LFQTQQTSLFQPQQTNSIFSQSQPQ--------QTNSIFSQ</a:t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Vv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  1 ---------------------------------MAFSLFSSPQPQQPQQLFQPQPQP--------------QQ</a:t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Nt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  1 VVKDMLHNTEVAVRSFMMLRPRFLRQSAPAA-ASATAPFQIPGQQQSSPFQTPGQQQ---SSPFSQITPFSQQ</a:t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Pb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  1 ---------------------------------MAFS-FSTP-PQQTPSLFQPQPQPFQQSSPLFPQQQQQQQ</a:t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Os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  1 -----------MAFSFASP-------------------------APQNPFQTP----------------AQAP</a:t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Zm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  1 -----------MAFSFASPPNPFQTPAASNPFQTPAASNPFQTPAAPNPFQTPTPAT------------SQAP</a:t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/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t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 48 SQPQQTNSIF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P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FF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TSLFQP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F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QQQL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N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QQQV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Y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F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T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N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D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K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PA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N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Y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TKW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D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LH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P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D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SQK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/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Vv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 27 PFQQP-NPFL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FF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QQLQ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---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QQF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P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FQQQQ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P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Y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F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T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N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D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K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PA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T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Y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TKW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D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LH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P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D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SQK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F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/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Nt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 70 PQQQQQLQFQ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FF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QQHQL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LQL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QQL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SQQQ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Y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F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T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N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D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KT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PA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T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Y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TKW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D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LH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P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D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SQK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/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Pb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 39 PQQHS-SSFR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FF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QQQQ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---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QQQ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QQQQ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-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Y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F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T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N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D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K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PA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Y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TKW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E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D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LH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P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D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SQK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T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/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Os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 22 SLSPSPFQFNL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P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FF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QPPP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---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APA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P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-----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M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Y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T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T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D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GK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PA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G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Y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N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TKW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E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E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LH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E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SQK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/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Zm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 51 SLSPSPFQFSF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-P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FF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P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---P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---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VAPA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P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PQPQH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K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M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Y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T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T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D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MK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PA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G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Y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N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TKW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E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E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LH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E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SQK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/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/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t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122 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LQIE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EKI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E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H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R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ES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RLDQC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R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Y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DS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V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SEG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FE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F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DAS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RIV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ELGG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IN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T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M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D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R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KA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V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H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ELM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IVAK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D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M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R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N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E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/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Vv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 97 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LQIE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ERI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E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Y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R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DES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RLDQC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G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R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Y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DS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V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ND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FE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DAS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RIV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ELGG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V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T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M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E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R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KA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V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ELM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VVK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D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M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R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N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T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E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/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Nt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143 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LQIE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ERI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E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Y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R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DKS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RLDQC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R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Y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DS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V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NDG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FE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V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DAS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RSI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ELGG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V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T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M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E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R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KA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I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ELM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VVVK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D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M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H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N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T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E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/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Pb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109 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LQIE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ERI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E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Y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R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DESK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RLDQC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R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Y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DS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V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NEG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FE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DAS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II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ELGG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I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T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M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E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R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KA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ELM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TNVK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D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M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R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N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T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E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/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Os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 87 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LQIE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DKI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R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E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Y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R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DESE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RLDQC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R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H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DS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I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TVN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FE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N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DAS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EI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ELGG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TT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T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M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M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E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R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E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KA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V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ELM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TVVN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E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M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M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R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N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T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E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/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Zm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119 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LQIE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DKV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R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D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Y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R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DECE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RLDQC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R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Y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DS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I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NVN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FE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DAS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RIV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ELGG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TT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T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V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M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E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R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E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KA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I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ELM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NVVN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E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M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M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W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N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T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E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/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/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t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194 I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V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R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FM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M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PRF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P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H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WKQGGGVVSVGS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PS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G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G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TNPAPASSGQQQAVTTTVQV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DFY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R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G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I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P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KK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P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T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F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L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T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V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/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Vv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170 V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V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R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FM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M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R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PRF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H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PGSG--AVSSAP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PS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AP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G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TVVPSAS-SQLTVTSMAPVF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DFY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G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P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RK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P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S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P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F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L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T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V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/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Nt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216 V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V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R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FM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M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R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PRF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R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SAP--AAASAT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PS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A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G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TVAQTAS-TQAHSTPNAPVF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DFY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R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G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I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P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KK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P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T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P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F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T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V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/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Pb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182 M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V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R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FM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M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H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PRF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H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NAGG-GASNAT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PS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PP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G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TTGIPGST-SQPASSSIVPVF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DFY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G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P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KK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P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S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P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F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T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V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/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Os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160 F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I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R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YM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M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R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PRF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I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R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PGAG--ANGGGSN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PS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GP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G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QSNQPVA--------LAPTI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DFY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G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I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P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KR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P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S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H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F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M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T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I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/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Zm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192 F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I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R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YL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M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R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PRF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T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R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TGAGV-ANGGSSN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PS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--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G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PPNQ-------------PVL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DFY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G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V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P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KR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P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S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I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F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M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H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T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V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/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/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t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267 V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RFE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K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Y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N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EC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R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W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V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E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ELE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LD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D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K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YSRH--ASL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E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SLPKVMSNVHD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F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F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V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H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VA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KVE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I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HQY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I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E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MR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T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Y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/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Vv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241 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RFE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K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Y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G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EC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R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W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I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E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ELE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-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ID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FD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R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NSSNGSSSL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SLPKVMSNVHD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F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F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V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H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VA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KVE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I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HQY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I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E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MK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M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Y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/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Nt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286 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RFE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K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Y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EC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R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W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V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E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ELE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M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LD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D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R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NSMNSSSSL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SLPKVMSNVHD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F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F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V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H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VA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KVE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I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HQY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I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E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MK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T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Y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/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Pb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259 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RFE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K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Y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G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EC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W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I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E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ELE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LD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E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R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NSSHPGSSL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SLPKVMSNVHD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F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F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V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H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VA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KVE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I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HQY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I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E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MK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T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Y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/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Os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223 N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RFE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K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Y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G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EC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CK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W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I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ELE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V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ME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NN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K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RQSAS----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E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SLPKVMSNVHD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Y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F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I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Y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VA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KVE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N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HQY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V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E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LK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TE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Y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/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Zm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249 N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RFE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C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Y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EC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CK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W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I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G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ELE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V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IE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TN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K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ISSDS----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D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SLPKVMSNVHD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Y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F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I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Y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VA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KVE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N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HQY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V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E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MK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E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YL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/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/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t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338 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D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RR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R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G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ECHD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PFLEA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D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RRE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T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K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EAA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K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RV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HPTLHLPA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TTST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P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T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V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G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LI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S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ATPGGSNPP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TSVPTS</a:t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Vv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314 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D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RR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R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G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DGND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PFLEA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D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RRE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T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K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EAA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K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WV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HPTLHLPA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VS---P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P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T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V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G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LF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S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STTGALTAP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TFASA</a:t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Nt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359 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D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RR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R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G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DGSD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PFLEA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D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RRE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T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K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EAA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R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RV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HPTLHLPA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IS---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P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T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V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G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LI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S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AAPGASSAP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TSSAVP</a:t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Pb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332 V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D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RR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R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G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DGND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PFLEA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D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RRE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R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R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K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EAA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K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R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HPTLHLPA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NS---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P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T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G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G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LF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S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ATSSASTAP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STATA</a:t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Os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292 H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E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RR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L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G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NAND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PFLEA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N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RRE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K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EAA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R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RV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HPTLHLPA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PV---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P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TT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I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G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TVT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S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-------QP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LIPSG</a:t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Zm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318 N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E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RR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N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G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NGSN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PFLEA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N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RRE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K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EAA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R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RV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HPTLHLPA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PA---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P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MP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I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PAT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S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-------QPQ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Q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PSFPSA</a:t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/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t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411 --NPSSG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G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FSFLN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TP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SGP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S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----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SSLF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TP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STAPTSSLFGPSPTPT----------------QTPLFGS-</a:t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Vv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384 ----SSG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G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FSLFG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TP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SAP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S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TTT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SSLF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T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TP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TTSAPVPSLFGTSGASPQTSLFNSSSSLFGSSSTPSLFGST</a:t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Nt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429 --SALPG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G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SLF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TP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VA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S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---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SSLF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T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TP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-----------------------------------------</a:t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Pb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402 PAPASSGN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FSLFN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TP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-SVP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S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SM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SSLF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TP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TTSAPVSTLFG-SAATP---------SLFG--SATQAFGAS</a:t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Os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355 ---ATSS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FPSF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TP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SAP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S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---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SSLF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TP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TTPTLSSNLFGTSGSAQ----------------LSTPFGTV</a:t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Zm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381 ---ATSS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A9A9A9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FSTF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TP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SAP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S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---S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SSLF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es-ES_tradnl" sz="980" b="1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Times New Roman"/>
              </a:rPr>
              <a:t>TP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TTPAPSANLFGASGSAQ----------------LTTPFGTA</a:t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/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At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451 SPASTFG--STQSLFG------QTTPSLTMPSQFGGATP---------GSGASFGSMTKSSRPKSRTTRR</a:t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Vv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454 STPSLFGSAATPSLFG------GAAPSFGNTPAGSSLFTTPFASGAATGSGASFGAASKSSKPKTRTARR</a:t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Nt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    ----------------------------------------------------------------------</a:t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Pb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462 SSAPALGSASTPSLFG------STTPAFGTISAGGSLFS-------------------------------</a:t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Os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406 STP-TLGSTPAPSGFGNTTPSFASTPALGGTSLFSTPFG-----GGATASGSSFGGTSKV-RSKPRGRR-</a:t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es-ES_tradnl" sz="980" b="1" i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Zm</a:t>
            </a:r>
            <a: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  <a:t>  432 STP-TLASTPAP-GFG------TSTTSLGGTSLFSTPFG-----GGATASGSSFGGASKG-RSKPRGRR-</a:t>
            </a:r>
            <a:br>
              <a:rPr lang="es-ES_tradnl" sz="98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Times New Roman"/>
              </a:rPr>
            </a:br>
            <a:endParaRPr lang="es-ES" sz="980" dirty="0"/>
          </a:p>
        </p:txBody>
      </p:sp>
    </p:spTree>
    <p:extLst>
      <p:ext uri="{BB962C8B-B14F-4D97-AF65-F5344CB8AC3E}">
        <p14:creationId xmlns:p14="http://schemas.microsoft.com/office/powerpoint/2010/main" val="36508991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6</TotalTime>
  <Words>8</Words>
  <Application>Microsoft Office PowerPoint</Application>
  <PresentationFormat>A4 (210 x 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ourier New</vt:lpstr>
      <vt:lpstr>Times New Roman</vt:lpstr>
      <vt:lpstr>Tema de Office</vt:lpstr>
      <vt:lpstr>Presentación de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Sanchez Garcia, Ana Belen</dc:creator>
  <cp:lastModifiedBy>Micol Molina, Jose Luis</cp:lastModifiedBy>
  <cp:revision>20</cp:revision>
  <cp:lastPrinted>2012-06-05T15:06:05Z</cp:lastPrinted>
  <dcterms:created xsi:type="dcterms:W3CDTF">2012-05-31T18:01:55Z</dcterms:created>
  <dcterms:modified xsi:type="dcterms:W3CDTF">2013-06-04T09:23:28Z</dcterms:modified>
</cp:coreProperties>
</file>